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0" r:id="rId2"/>
    <p:sldId id="286" r:id="rId3"/>
    <p:sldId id="283" r:id="rId4"/>
    <p:sldId id="285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33" autoAdjust="0"/>
  </p:normalViewPr>
  <p:slideViewPr>
    <p:cSldViewPr snapToGrid="0">
      <p:cViewPr varScale="1">
        <p:scale>
          <a:sx n="62" d="100"/>
          <a:sy n="62" d="100"/>
        </p:scale>
        <p:origin x="102" y="8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45B1B7-297F-436E-A21D-B3E194809943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1E97D0-29B6-4FDC-B798-602DBC1582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615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3A30B5-3315-62F6-B1A0-77706C4CF2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52DB24F-BE76-FA3A-1517-523D0AD5B0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9134ABF-B3D0-686C-AD3B-1FAAC7F71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0E7838F-BF37-FEC4-576C-92CFF13F8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1D47D29-7588-90BA-9724-25B6BB68B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15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150D96-2BCA-5D8C-ADEE-1B3D74057A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45BE4C4-5CA4-9649-34F1-15ED2B5557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06BF94-0CEB-1BA2-11D9-6766A245C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94BDCC-9873-97FA-F294-656757BF4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FCDA6B5-87F2-3279-D3D9-E5C2E3B0C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6618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91AD189-46CB-9CDA-898F-9A7DC6E620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DAF11B3-0AD1-EC39-6DF5-A59669FC28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388620F-0E26-552E-CAE1-ECC292F65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853451-310D-E71A-029B-5EE493A6A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5DD3CF-CAA1-B2E8-EF41-D62C0D62F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5194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0B54C1-5A7C-A51D-AD23-3BCB4AB09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0FCD09B-C8B8-B67E-C396-5CD2BF9C57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EA05FEC-47C8-387A-86BC-3153A3A01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70E065-D511-99A5-385E-963385F6B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8A22946-2799-F07F-1569-873253EC3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1818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58B6398-78BD-92A5-C3B9-57A590542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B457F99-F8F6-EA41-0143-E9EB54E61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CF0738B-BBEE-F494-651E-E5F70EB4F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131E38C-4842-FDC6-0BCA-60001261F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6C237F-61F9-82D4-DDB7-EA5070A24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297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F41BF70-C5C3-DBD0-4E6A-D69E2ED8C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694CE1B-9DF5-EF3D-1C5C-113AECC1FC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B3CD1D4-29EE-89B7-4ABF-FDB855762E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4401C50-AC44-9C3F-1DE1-5F943574C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F5346F6-829A-7E72-8A14-AFBE291A1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423B798-B690-910A-0FBE-DA94B7A1D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655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6290F6-D99A-1979-8D9B-43D1C8CC1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B37687D-04DC-3058-2C8E-DC9544E5F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2954CB1-D7FF-D8E1-DD88-9494D5508D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7E7D904-2042-9CEB-A914-3A1888A0F6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6161CAA-6229-2098-9A7B-55CCEB8217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10E97EF9-4665-D6A4-61AB-05E69910F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1282FE9-34D3-1F95-8810-9DEE8E392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B163772-6906-6DF8-88C4-1E9EB9F0A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7617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1795229-3FEC-83CE-253F-0601B7B30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2AF62F3-00C2-9838-18BD-8BC351A2A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8336E572-C7CC-5E62-1D48-FCE3BDAD9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6D262FA-4A93-8CDB-E636-547D75B8A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394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3602C53-DA29-A087-4F15-E7897700F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E03609F-7645-1FBD-6E8C-AFA668CEA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9D8E263-B935-C752-6241-55BCC965F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0430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16D88B-D1C5-85DE-00CD-8AE9B1FC1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4DF3948-8AE7-1BF5-39E7-E7E0F7919D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D143FE6-D5A9-CC95-95E1-EF282884C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F6B04BD-EB50-77D8-7160-897C78B27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F2A6195-A022-A01B-D537-CF62FEE64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F37AD4-CB92-E558-D29F-68575C507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544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C1F2703-A740-A622-1E08-C57EC0C657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8D0F0AF-1FA7-E079-2CF7-16CD4F52E5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3BC4D4C-66AF-FF3D-33AE-9C78B0911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992454C-3099-C245-D845-955124D1C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010E0DF-E9F9-1E78-8F67-C41BB6741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B1B85B-321D-A0AD-6E5C-849B3F1BA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9471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059CA21-E532-9105-0F1F-EB0C85EBF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72CD6A-7DC3-0105-CF83-97C227206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B218B48-6957-9AE9-C4FD-E62BA52411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A7A9A9-3311-4A46-AD9B-19CC54309F2A}" type="datetimeFigureOut">
              <a:rPr lang="ko-KR" altLang="en-US" smtClean="0"/>
              <a:t>2025-04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8EDDCFD-E067-9EC5-CACA-681D7C4895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C815CE7-6CCC-1081-3F63-57132C3B22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F57801-3C20-4AFB-B697-BD170F03E4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2064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904E75B-8E8C-E1A1-D2D1-BFC032BDC5C3}"/>
              </a:ext>
            </a:extLst>
          </p:cNvPr>
          <p:cNvSpPr txBox="1"/>
          <p:nvPr/>
        </p:nvSpPr>
        <p:spPr>
          <a:xfrm>
            <a:off x="275771" y="0"/>
            <a:ext cx="82423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 err="1"/>
              <a:t>Supplenentary</a:t>
            </a:r>
            <a:r>
              <a:rPr lang="en-US" altLang="ko-KR" sz="1800" b="1" dirty="0"/>
              <a:t> Figure. </a:t>
            </a:r>
            <a:r>
              <a:rPr lang="en-US" altLang="ko-KR" b="1" dirty="0"/>
              <a:t>S</a:t>
            </a:r>
            <a:r>
              <a:rPr lang="en-US" altLang="ko-KR" sz="1800" b="1" dirty="0"/>
              <a:t>1</a:t>
            </a:r>
          </a:p>
          <a:p>
            <a:endParaRPr lang="en-US" altLang="ko-KR" sz="1800" i="1" dirty="0"/>
          </a:p>
          <a:p>
            <a:r>
              <a:rPr lang="en-US" altLang="ko-KR" sz="1800" i="1" dirty="0"/>
              <a:t>(2.1. </a:t>
            </a:r>
            <a:r>
              <a:rPr lang="en-US" altLang="ko-KR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ample preparation</a:t>
            </a:r>
            <a:r>
              <a:rPr lang="en-US" altLang="ko-KR" sz="1800" i="1" dirty="0"/>
              <a:t>) </a:t>
            </a:r>
            <a:endParaRPr lang="ko-KR" altLang="en-US" sz="1800" i="1" baseline="30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DFBCDE-0C83-2D07-9768-4C914F778366}"/>
              </a:ext>
            </a:extLst>
          </p:cNvPr>
          <p:cNvSpPr txBox="1"/>
          <p:nvPr/>
        </p:nvSpPr>
        <p:spPr>
          <a:xfrm>
            <a:off x="6623435" y="6106825"/>
            <a:ext cx="5568565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700" b="1" dirty="0"/>
              <a:t>Figure S1. Flow diagram for the preparation of </a:t>
            </a:r>
            <a:r>
              <a:rPr lang="en-US" altLang="ko-KR" sz="1700" b="1" i="1" dirty="0" err="1"/>
              <a:t>Dendropanax</a:t>
            </a:r>
            <a:r>
              <a:rPr lang="en-US" altLang="ko-KR" sz="1700" b="1" i="1" dirty="0"/>
              <a:t> </a:t>
            </a:r>
            <a:r>
              <a:rPr lang="en-US" altLang="ko-KR" sz="1700" b="1" i="1" dirty="0" err="1"/>
              <a:t>morbiferus</a:t>
            </a:r>
            <a:r>
              <a:rPr lang="en-US" altLang="ko-KR" sz="1700" b="1" i="1" dirty="0"/>
              <a:t> </a:t>
            </a:r>
            <a:r>
              <a:rPr lang="en-US" altLang="ko-KR" sz="1700" b="1" i="1" dirty="0" err="1"/>
              <a:t>Lév</a:t>
            </a:r>
            <a:r>
              <a:rPr lang="en-US" altLang="ko-KR" sz="1700" b="1" i="1" dirty="0"/>
              <a:t>. </a:t>
            </a:r>
            <a:r>
              <a:rPr lang="en-US" altLang="ko-KR" sz="1700" b="1" dirty="0"/>
              <a:t>leaf water extracts.</a:t>
            </a:r>
            <a:endParaRPr lang="ko-KR" altLang="en-US" sz="17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846392-4B57-AD56-C0B7-5CBA009FE197}"/>
              </a:ext>
            </a:extLst>
          </p:cNvPr>
          <p:cNvSpPr txBox="1"/>
          <p:nvPr/>
        </p:nvSpPr>
        <p:spPr>
          <a:xfrm>
            <a:off x="3797352" y="14738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y leaves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FFB44D-A243-1EB6-B66C-F1F09D2E2B46}"/>
              </a:ext>
            </a:extLst>
          </p:cNvPr>
          <p:cNvSpPr txBox="1"/>
          <p:nvPr/>
        </p:nvSpPr>
        <p:spPr>
          <a:xfrm>
            <a:off x="3797352" y="1010911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ng water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C3E163-535B-2387-E836-ED34F3383BBD}"/>
              </a:ext>
            </a:extLst>
          </p:cNvPr>
          <p:cNvSpPr txBox="1"/>
          <p:nvPr/>
        </p:nvSpPr>
        <p:spPr>
          <a:xfrm>
            <a:off x="3797352" y="1883944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9E3323-32F0-1EAF-5C8A-0E46D002A983}"/>
              </a:ext>
            </a:extLst>
          </p:cNvPr>
          <p:cNvSpPr txBox="1"/>
          <p:nvPr/>
        </p:nvSpPr>
        <p:spPr>
          <a:xfrm>
            <a:off x="3797352" y="2758068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tratio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081A37-13B2-64DD-E733-3C68DC624744}"/>
              </a:ext>
            </a:extLst>
          </p:cNvPr>
          <p:cNvSpPr txBox="1"/>
          <p:nvPr/>
        </p:nvSpPr>
        <p:spPr>
          <a:xfrm>
            <a:off x="3797352" y="3624876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FF6B20D-9B12-BF67-A2BF-BA9449F19CCA}"/>
              </a:ext>
            </a:extLst>
          </p:cNvPr>
          <p:cNvSpPr txBox="1"/>
          <p:nvPr/>
        </p:nvSpPr>
        <p:spPr>
          <a:xfrm>
            <a:off x="3797352" y="4487940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ze drying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E9A91C-2EC5-9A9D-AEDA-0CF15E926B92}"/>
              </a:ext>
            </a:extLst>
          </p:cNvPr>
          <p:cNvSpPr txBox="1"/>
          <p:nvPr/>
        </p:nvSpPr>
        <p:spPr>
          <a:xfrm>
            <a:off x="3797352" y="5351003"/>
            <a:ext cx="1620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ling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72AB2F2-B008-5DFC-B993-5529AF2D62CC}"/>
              </a:ext>
            </a:extLst>
          </p:cNvPr>
          <p:cNvSpPr txBox="1"/>
          <p:nvPr/>
        </p:nvSpPr>
        <p:spPr>
          <a:xfrm>
            <a:off x="3797352" y="6211669"/>
            <a:ext cx="16200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substanc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aw material)</a:t>
            </a:r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2381D032-03DF-275B-C1DF-D00361410377}"/>
              </a:ext>
            </a:extLst>
          </p:cNvPr>
          <p:cNvCxnSpPr>
            <a:stCxn id="2" idx="2"/>
            <a:endCxn id="4" idx="0"/>
          </p:cNvCxnSpPr>
          <p:nvPr/>
        </p:nvCxnSpPr>
        <p:spPr>
          <a:xfrm>
            <a:off x="4607352" y="384070"/>
            <a:ext cx="0" cy="62684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직선 화살표 연결선 13">
            <a:extLst>
              <a:ext uri="{FF2B5EF4-FFF2-40B4-BE49-F238E27FC236}">
                <a16:creationId xmlns:a16="http://schemas.microsoft.com/office/drawing/2014/main" id="{8565796A-161F-EF62-0557-B0D00ADBA92D}"/>
              </a:ext>
            </a:extLst>
          </p:cNvPr>
          <p:cNvCxnSpPr>
            <a:stCxn id="4" idx="2"/>
            <a:endCxn id="5" idx="0"/>
          </p:cNvCxnSpPr>
          <p:nvPr/>
        </p:nvCxnSpPr>
        <p:spPr>
          <a:xfrm>
            <a:off x="4607352" y="1380243"/>
            <a:ext cx="0" cy="5037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직선 화살표 연결선 14">
            <a:extLst>
              <a:ext uri="{FF2B5EF4-FFF2-40B4-BE49-F238E27FC236}">
                <a16:creationId xmlns:a16="http://schemas.microsoft.com/office/drawing/2014/main" id="{48F75A95-333B-29C4-922C-8B5C87651CA3}"/>
              </a:ext>
            </a:extLst>
          </p:cNvPr>
          <p:cNvCxnSpPr>
            <a:stCxn id="5" idx="2"/>
            <a:endCxn id="6" idx="0"/>
          </p:cNvCxnSpPr>
          <p:nvPr/>
        </p:nvCxnSpPr>
        <p:spPr>
          <a:xfrm>
            <a:off x="4607352" y="2253276"/>
            <a:ext cx="0" cy="5047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C06B7971-DFF8-90DC-8984-6C6EE07A5C5D}"/>
              </a:ext>
            </a:extLst>
          </p:cNvPr>
          <p:cNvCxnSpPr>
            <a:stCxn id="6" idx="2"/>
            <a:endCxn id="9" idx="0"/>
          </p:cNvCxnSpPr>
          <p:nvPr/>
        </p:nvCxnSpPr>
        <p:spPr>
          <a:xfrm>
            <a:off x="4607352" y="3127400"/>
            <a:ext cx="0" cy="49747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직선 화살표 연결선 16">
            <a:extLst>
              <a:ext uri="{FF2B5EF4-FFF2-40B4-BE49-F238E27FC236}">
                <a16:creationId xmlns:a16="http://schemas.microsoft.com/office/drawing/2014/main" id="{5600830C-040B-8681-D0F0-90336591C8DD}"/>
              </a:ext>
            </a:extLst>
          </p:cNvPr>
          <p:cNvCxnSpPr>
            <a:stCxn id="9" idx="2"/>
            <a:endCxn id="10" idx="0"/>
          </p:cNvCxnSpPr>
          <p:nvPr/>
        </p:nvCxnSpPr>
        <p:spPr>
          <a:xfrm>
            <a:off x="4607352" y="3994208"/>
            <a:ext cx="0" cy="49373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직선 화살표 연결선 17">
            <a:extLst>
              <a:ext uri="{FF2B5EF4-FFF2-40B4-BE49-F238E27FC236}">
                <a16:creationId xmlns:a16="http://schemas.microsoft.com/office/drawing/2014/main" id="{BB134E72-511A-F82D-8625-44EE2DE872C3}"/>
              </a:ext>
            </a:extLst>
          </p:cNvPr>
          <p:cNvCxnSpPr>
            <a:stCxn id="10" idx="2"/>
            <a:endCxn id="11" idx="0"/>
          </p:cNvCxnSpPr>
          <p:nvPr/>
        </p:nvCxnSpPr>
        <p:spPr>
          <a:xfrm>
            <a:off x="4607352" y="4857272"/>
            <a:ext cx="0" cy="4937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94AB46FF-6D44-5FCD-DAB7-0E3600C3368D}"/>
              </a:ext>
            </a:extLst>
          </p:cNvPr>
          <p:cNvCxnSpPr>
            <a:stCxn id="11" idx="2"/>
            <a:endCxn id="12" idx="0"/>
          </p:cNvCxnSpPr>
          <p:nvPr/>
        </p:nvCxnSpPr>
        <p:spPr>
          <a:xfrm>
            <a:off x="4607352" y="5720335"/>
            <a:ext cx="0" cy="4913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BB2A6CA-E8F9-3DA3-8D75-68D25E74166C}"/>
              </a:ext>
            </a:extLst>
          </p:cNvPr>
          <p:cNvSpPr txBox="1"/>
          <p:nvPr/>
        </p:nvSpPr>
        <p:spPr>
          <a:xfrm>
            <a:off x="5870523" y="14738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B8A64E-5A55-EC8F-381A-08EA8F3DB594}"/>
              </a:ext>
            </a:extLst>
          </p:cNvPr>
          <p:cNvSpPr txBox="1"/>
          <p:nvPr/>
        </p:nvSpPr>
        <p:spPr>
          <a:xfrm>
            <a:off x="5870523" y="1010911"/>
            <a:ext cx="2345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times distilled water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A12C20-1B56-8CBF-45CA-57E2FF3E981E}"/>
              </a:ext>
            </a:extLst>
          </p:cNvPr>
          <p:cNvSpPr txBox="1"/>
          <p:nvPr/>
        </p:nvSpPr>
        <p:spPr>
          <a:xfrm>
            <a:off x="5870523" y="1883944"/>
            <a:ext cx="2143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95 ~ 100°C for 4 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22285E2-2102-38B8-6C33-1478F55B302D}"/>
              </a:ext>
            </a:extLst>
          </p:cNvPr>
          <p:cNvSpPr txBox="1"/>
          <p:nvPr/>
        </p:nvSpPr>
        <p:spPr>
          <a:xfrm>
            <a:off x="5870523" y="2712651"/>
            <a:ext cx="2071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l-GR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micro-filter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B9E347-24D1-5D6B-23C8-78218C0467E4}"/>
              </a:ext>
            </a:extLst>
          </p:cNvPr>
          <p:cNvSpPr txBox="1"/>
          <p:nvPr/>
        </p:nvSpPr>
        <p:spPr>
          <a:xfrm>
            <a:off x="5870523" y="3624876"/>
            <a:ext cx="2073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 ~ 16 brix at 45°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CA3F979-3D7B-69CB-6CF2-9DF88CDA833A}"/>
              </a:ext>
            </a:extLst>
          </p:cNvPr>
          <p:cNvSpPr txBox="1"/>
          <p:nvPr/>
        </p:nvSpPr>
        <p:spPr>
          <a:xfrm>
            <a:off x="5870523" y="4487940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-40°C for 96 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2067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566F79-428E-C631-97F1-88F55D046A40}"/>
              </a:ext>
            </a:extLst>
          </p:cNvPr>
          <p:cNvSpPr txBox="1"/>
          <p:nvPr/>
        </p:nvSpPr>
        <p:spPr>
          <a:xfrm>
            <a:off x="1407886" y="6504057"/>
            <a:ext cx="9512300" cy="353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700" b="1" dirty="0"/>
              <a:t>Continue</a:t>
            </a:r>
            <a:endParaRPr lang="ko-KR" altLang="en-US" sz="1700" b="1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86AD7018-2D61-37C2-E9C7-FC4B905069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3199"/>
            <a:ext cx="11988800" cy="61442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1101407-55FA-239F-8415-D97DFE947408}"/>
              </a:ext>
            </a:extLst>
          </p:cNvPr>
          <p:cNvSpPr txBox="1"/>
          <p:nvPr/>
        </p:nvSpPr>
        <p:spPr>
          <a:xfrm>
            <a:off x="116115" y="190892"/>
            <a:ext cx="211908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 err="1"/>
              <a:t>Supplenentary</a:t>
            </a:r>
            <a:r>
              <a:rPr lang="en-US" altLang="ko-KR" sz="1800" b="1" dirty="0"/>
              <a:t> </a:t>
            </a:r>
          </a:p>
          <a:p>
            <a:r>
              <a:rPr lang="en-US" altLang="ko-KR" sz="1800" b="1" dirty="0"/>
              <a:t>Figure. </a:t>
            </a:r>
            <a:r>
              <a:rPr lang="en-US" altLang="ko-KR" b="1" dirty="0"/>
              <a:t>S2</a:t>
            </a:r>
            <a:endParaRPr lang="en-US" altLang="ko-KR" sz="1800" b="1" dirty="0"/>
          </a:p>
          <a:p>
            <a:endParaRPr lang="en-US" altLang="ko-KR" sz="1800" i="1" dirty="0"/>
          </a:p>
        </p:txBody>
      </p:sp>
    </p:spTree>
    <p:extLst>
      <p:ext uri="{BB962C8B-B14F-4D97-AF65-F5344CB8AC3E}">
        <p14:creationId xmlns:p14="http://schemas.microsoft.com/office/powerpoint/2010/main" val="1409650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EFD9153-FF10-9C47-DAEF-E58F27474D12}"/>
              </a:ext>
            </a:extLst>
          </p:cNvPr>
          <p:cNvSpPr txBox="1"/>
          <p:nvPr/>
        </p:nvSpPr>
        <p:spPr>
          <a:xfrm>
            <a:off x="1407886" y="6504057"/>
            <a:ext cx="9512300" cy="353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700" b="1" dirty="0"/>
              <a:t>Continue</a:t>
            </a:r>
            <a:endParaRPr lang="ko-KR" altLang="en-US" sz="1700" b="1" dirty="0"/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055CB954-E9E0-5D11-B60B-5D8AD6A268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7832" y="246743"/>
            <a:ext cx="8791193" cy="6139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5168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00EEF3D-8671-C286-C352-ADE815BC057D}"/>
              </a:ext>
            </a:extLst>
          </p:cNvPr>
          <p:cNvSpPr txBox="1"/>
          <p:nvPr/>
        </p:nvSpPr>
        <p:spPr>
          <a:xfrm>
            <a:off x="1494971" y="4718735"/>
            <a:ext cx="95123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700" b="1" dirty="0"/>
              <a:t>Figure S2.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ragmentation scheme of the compounds identified from the DMWE by the </a:t>
            </a:r>
            <a:r>
              <a:rPr lang="en-US" altLang="ko-KR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HP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C-TOF/MS analysis.</a:t>
            </a:r>
            <a:r>
              <a:rPr lang="en-US" altLang="ko-KR" sz="1700" b="1" dirty="0"/>
              <a:t> </a:t>
            </a:r>
            <a:endParaRPr lang="ko-KR" altLang="en-US" sz="1700" b="1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9DF8218-668F-7D3C-670B-1A4F0E141B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1016" y="1375135"/>
            <a:ext cx="6053853" cy="21337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6924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5</TotalTime>
  <Words>103</Words>
  <Application>Microsoft Office PowerPoint</Application>
  <PresentationFormat>와이드스크린</PresentationFormat>
  <Paragraphs>2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iwoong Heo</dc:creator>
  <cp:lastModifiedBy>김민정</cp:lastModifiedBy>
  <cp:revision>79</cp:revision>
  <dcterms:created xsi:type="dcterms:W3CDTF">2024-12-03T09:10:26Z</dcterms:created>
  <dcterms:modified xsi:type="dcterms:W3CDTF">2025-04-29T10:56:25Z</dcterms:modified>
</cp:coreProperties>
</file>